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889" autoAdjust="0"/>
    <p:restoredTop sz="94660"/>
  </p:normalViewPr>
  <p:slideViewPr>
    <p:cSldViewPr snapToGrid="0">
      <p:cViewPr varScale="1">
        <p:scale>
          <a:sx n="87" d="100"/>
          <a:sy n="87" d="100"/>
        </p:scale>
        <p:origin x="85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4CEDCF-30ED-4349-92C3-94D7C1547B0B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2A3DAA-415A-49A4-9DC3-BBD04802337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9727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Death </a:t>
            </a:r>
            <a:r>
              <a:rPr lang="ko-KR" altLang="en-US" dirty="0" smtClean="0"/>
              <a:t>항목 추가</a:t>
            </a:r>
            <a:r>
              <a:rPr lang="en-US" altLang="ko-KR" dirty="0" smtClean="0"/>
              <a:t>_CI </a:t>
            </a:r>
            <a:r>
              <a:rPr lang="ko-KR" altLang="en-US" dirty="0" err="1" smtClean="0"/>
              <a:t>수정필요</a:t>
            </a:r>
            <a:endParaRPr lang="en-US" altLang="ko-KR" dirty="0" smtClean="0"/>
          </a:p>
          <a:p>
            <a:r>
              <a:rPr lang="en-US" altLang="ko-KR" dirty="0" smtClean="0">
                <a:sym typeface="Wingdings" panose="05000000000000000000" pitchFamily="2" charset="2"/>
              </a:rPr>
              <a:t>TCGA-KIRP </a:t>
            </a:r>
            <a:r>
              <a:rPr lang="ko-KR" altLang="en-US" dirty="0" smtClean="0">
                <a:sym typeface="Wingdings" panose="05000000000000000000" pitchFamily="2" charset="2"/>
              </a:rPr>
              <a:t>데이터로 </a:t>
            </a:r>
            <a:r>
              <a:rPr lang="en-US" altLang="ko-KR" dirty="0" smtClean="0">
                <a:sym typeface="Wingdings" panose="05000000000000000000" pitchFamily="2" charset="2"/>
              </a:rPr>
              <a:t>4</a:t>
            </a:r>
            <a:r>
              <a:rPr lang="ko-KR" altLang="en-US" dirty="0" smtClean="0">
                <a:sym typeface="Wingdings" panose="05000000000000000000" pitchFamily="2" charset="2"/>
              </a:rPr>
              <a:t>개 </a:t>
            </a:r>
            <a:r>
              <a:rPr lang="ko-KR" altLang="en-US" dirty="0" err="1" smtClean="0">
                <a:sym typeface="Wingdings" panose="05000000000000000000" pitchFamily="2" charset="2"/>
              </a:rPr>
              <a:t>생존특이</a:t>
            </a:r>
            <a:r>
              <a:rPr lang="ko-KR" altLang="en-US" dirty="0" smtClean="0">
                <a:sym typeface="Wingdings" panose="05000000000000000000" pitchFamily="2" charset="2"/>
              </a:rPr>
              <a:t> 유전자에 대해 </a:t>
            </a:r>
            <a:r>
              <a:rPr lang="en-US" altLang="ko-KR" dirty="0" smtClean="0">
                <a:sym typeface="Wingdings" panose="05000000000000000000" pitchFamily="2" charset="2"/>
              </a:rPr>
              <a:t>Fisher’s exact test </a:t>
            </a:r>
            <a:r>
              <a:rPr lang="ko-KR" altLang="en-US" dirty="0" smtClean="0">
                <a:sym typeface="Wingdings" panose="05000000000000000000" pitchFamily="2" charset="2"/>
              </a:rPr>
              <a:t>진행 </a:t>
            </a:r>
            <a:r>
              <a:rPr lang="en-US" altLang="ko-KR" dirty="0" smtClean="0">
                <a:sym typeface="Wingdings" panose="05000000000000000000" pitchFamily="2" charset="2"/>
              </a:rPr>
              <a:t>(Table 8</a:t>
            </a:r>
            <a:r>
              <a:rPr lang="ko-KR" altLang="en-US" dirty="0" smtClean="0">
                <a:sym typeface="Wingdings" panose="05000000000000000000" pitchFamily="2" charset="2"/>
              </a:rPr>
              <a:t>과 동일 형태</a:t>
            </a:r>
            <a:r>
              <a:rPr lang="en-US" altLang="ko-KR" dirty="0" smtClean="0">
                <a:sym typeface="Wingdings" panose="05000000000000000000" pitchFamily="2" charset="2"/>
              </a:rPr>
              <a:t>)</a:t>
            </a:r>
            <a:endParaRPr lang="ko-KR" altLang="en-US" dirty="0" smtClean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E6F53D-3345-49B2-9AD2-C0645D187359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83260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8733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856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0618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5458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9272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4597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4643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0367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6484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3669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655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AA6F2-0B08-4C53-BA6A-6C182F6A2DD9}" type="datetimeFigureOut">
              <a:rPr lang="ko-KR" altLang="en-US" smtClean="0"/>
              <a:t>2024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E37158-228B-4AA5-B444-568F580775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0397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402495" y="1642655"/>
            <a:ext cx="103632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kern="1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맑은 고딕" panose="020B0503020000020004" pitchFamily="50" charset="-127"/>
                <a:cs typeface="Times New Roman"/>
              </a:rPr>
              <a:t>Table S1. 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Gene Set Enrichment Analysis on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17 survival-specific 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genes identified in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TCGA-KIRP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.</a:t>
            </a:r>
            <a:r>
              <a:rPr kumimoji="0" lang="en-US" altLang="ko-KR" sz="1200" b="1" i="0" u="none" strike="noStrike" kern="1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맑은 고딕" panose="020B0503020000020004" pitchFamily="50" charset="-127"/>
                <a:cs typeface="Times New Roman"/>
              </a:rPr>
              <a:t> </a:t>
            </a:r>
            <a:endParaRPr lang="en-US" altLang="ko-KR" sz="1200" b="1" kern="100" dirty="0">
              <a:solidFill>
                <a:prstClr val="black"/>
              </a:solidFill>
              <a:latin typeface="Times New Roman"/>
              <a:cs typeface="Times New Roman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282121"/>
              </p:ext>
            </p:extLst>
          </p:nvPr>
        </p:nvGraphicFramePr>
        <p:xfrm>
          <a:off x="1402495" y="2025161"/>
          <a:ext cx="8978899" cy="3257550"/>
        </p:xfrm>
        <a:graphic>
          <a:graphicData uri="http://schemas.openxmlformats.org/drawingml/2006/table">
            <a:tbl>
              <a:tblPr/>
              <a:tblGrid>
                <a:gridCol w="685073">
                  <a:extLst>
                    <a:ext uri="{9D8B030D-6E8A-4147-A177-3AD203B41FA5}">
                      <a16:colId xmlns:a16="http://schemas.microsoft.com/office/drawing/2014/main" val="935454562"/>
                    </a:ext>
                  </a:extLst>
                </a:gridCol>
                <a:gridCol w="5011184">
                  <a:extLst>
                    <a:ext uri="{9D8B030D-6E8A-4147-A177-3AD203B41FA5}">
                      <a16:colId xmlns:a16="http://schemas.microsoft.com/office/drawing/2014/main" val="905574428"/>
                    </a:ext>
                  </a:extLst>
                </a:gridCol>
                <a:gridCol w="1094214">
                  <a:extLst>
                    <a:ext uri="{9D8B030D-6E8A-4147-A177-3AD203B41FA5}">
                      <a16:colId xmlns:a16="http://schemas.microsoft.com/office/drawing/2014/main" val="2990719527"/>
                    </a:ext>
                  </a:extLst>
                </a:gridCol>
                <a:gridCol w="1094214">
                  <a:extLst>
                    <a:ext uri="{9D8B030D-6E8A-4147-A177-3AD203B41FA5}">
                      <a16:colId xmlns:a16="http://schemas.microsoft.com/office/drawing/2014/main" val="3259958475"/>
                    </a:ext>
                  </a:extLst>
                </a:gridCol>
                <a:gridCol w="1094214">
                  <a:extLst>
                    <a:ext uri="{9D8B030D-6E8A-4147-A177-3AD203B41FA5}">
                      <a16:colId xmlns:a16="http://schemas.microsoft.com/office/drawing/2014/main" val="289350891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am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dds rati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mbined scor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61121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imary Amine Oxidase Activity (GO:000813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5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9.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18.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0781439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xidoreductase Activity, Acting On The CH-NH2 Group Of Donors, Oxygen As Acceptor (GO:001664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59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8.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66.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20723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istone Reader Activity (GO:0140566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67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8.3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90.6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25601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RN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(Guanine)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ethyltransferas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Activity (GO:001642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93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4.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83.7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06317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RNA Methyltransferase Activity (GO:0008175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4.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69.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29453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ransmembrane-Ephrin Receptor Activity (GO:0005005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18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6.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25.9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06834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Ephrin Receptor Activity (GO:000500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2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9.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89.3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70556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NA Stem-Loop Binding (GO:003561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68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5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8.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12619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ysine-Acetylated Histone Binding (GO:007057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93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6.7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3.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83924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cetylation-Dependent Protein Binding (GO:014003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93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6.7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23.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93965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RNA 5'-UTR Binding (GO:004802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02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4.2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1.6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68034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DP Binding (GO:004353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27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7.9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1.5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08143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NA Polymerase II Complex Binding (GO:000099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6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.5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1.6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9650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aste Receptor Activity (GO:000852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60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1.5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1.6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095394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-adenosylmethionine-dependent Methyltransferase Activity (GO:000875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16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.4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0.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8297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7645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360059" y="1275255"/>
            <a:ext cx="103632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200" b="1" i="0" u="none" strike="noStrike" kern="1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맑은 고딕" panose="020B0503020000020004" pitchFamily="50" charset="-127"/>
                <a:cs typeface="Times New Roman"/>
              </a:rPr>
              <a:t>Table S2. 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Gene Set Enrichment Analysis on </a:t>
            </a:r>
            <a:r>
              <a:rPr lang="en-US" altLang="ko-KR" sz="1200" b="1" kern="100" dirty="0" smtClean="0">
                <a:solidFill>
                  <a:prstClr val="black"/>
                </a:solidFill>
                <a:latin typeface="Times New Roman"/>
                <a:cs typeface="Times New Roman"/>
              </a:rPr>
              <a:t>10 survival-specific </a:t>
            </a:r>
            <a:r>
              <a:rPr lang="en-US" altLang="ko-KR" sz="1200" b="1" kern="100" dirty="0">
                <a:solidFill>
                  <a:prstClr val="black"/>
                </a:solidFill>
                <a:latin typeface="Times New Roman"/>
                <a:cs typeface="Times New Roman"/>
              </a:rPr>
              <a:t>genes identified in Korean-KIRP.</a:t>
            </a:r>
            <a:r>
              <a:rPr kumimoji="0" lang="en-US" altLang="ko-KR" sz="1200" b="1" i="0" u="none" strike="noStrike" kern="1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맑은 고딕" panose="020B0503020000020004" pitchFamily="50" charset="-127"/>
                <a:cs typeface="Times New Roman"/>
              </a:rPr>
              <a:t> </a:t>
            </a:r>
            <a:endParaRPr lang="en-US" altLang="ko-KR" sz="1200" b="1" kern="100" dirty="0">
              <a:solidFill>
                <a:prstClr val="black"/>
              </a:solidFill>
              <a:latin typeface="Times New Roman"/>
              <a:cs typeface="Times New Roman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/>
          </p:nvPr>
        </p:nvGraphicFramePr>
        <p:xfrm>
          <a:off x="1439572" y="1656571"/>
          <a:ext cx="8978899" cy="2876550"/>
        </p:xfrm>
        <a:graphic>
          <a:graphicData uri="http://schemas.openxmlformats.org/drawingml/2006/table">
            <a:tbl>
              <a:tblPr/>
              <a:tblGrid>
                <a:gridCol w="685073">
                  <a:extLst>
                    <a:ext uri="{9D8B030D-6E8A-4147-A177-3AD203B41FA5}">
                      <a16:colId xmlns:a16="http://schemas.microsoft.com/office/drawing/2014/main" val="2735207448"/>
                    </a:ext>
                  </a:extLst>
                </a:gridCol>
                <a:gridCol w="5011184">
                  <a:extLst>
                    <a:ext uri="{9D8B030D-6E8A-4147-A177-3AD203B41FA5}">
                      <a16:colId xmlns:a16="http://schemas.microsoft.com/office/drawing/2014/main" val="1618128625"/>
                    </a:ext>
                  </a:extLst>
                </a:gridCol>
                <a:gridCol w="1094214">
                  <a:extLst>
                    <a:ext uri="{9D8B030D-6E8A-4147-A177-3AD203B41FA5}">
                      <a16:colId xmlns:a16="http://schemas.microsoft.com/office/drawing/2014/main" val="2741321432"/>
                    </a:ext>
                  </a:extLst>
                </a:gridCol>
                <a:gridCol w="1094214">
                  <a:extLst>
                    <a:ext uri="{9D8B030D-6E8A-4147-A177-3AD203B41FA5}">
                      <a16:colId xmlns:a16="http://schemas.microsoft.com/office/drawing/2014/main" val="244891520"/>
                    </a:ext>
                  </a:extLst>
                </a:gridCol>
                <a:gridCol w="1094214">
                  <a:extLst>
                    <a:ext uri="{9D8B030D-6E8A-4147-A177-3AD203B41FA5}">
                      <a16:colId xmlns:a16="http://schemas.microsoft.com/office/drawing/2014/main" val="353323538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.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am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-valu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dds rati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mbined scor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794474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otein Tyrosine Kinase Activity (GO:000471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1.2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5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62427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hosphatase Binding (GO:0019902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5.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98.2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52299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otein Phosphatase Binding (GO:0019903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3.9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88.0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07047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orphogen Activity (GO:0016015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6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44.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80.4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53459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rowth Hormone Receptor Binding (GO:000513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79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7.1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51.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98280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biquitin Protein Ligase Binding (GO:0031625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9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8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9.2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6226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Ubiquitin-Like Protein Ligase Binding (GO:0044389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9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.1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1.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54293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rmone Receptor Binding (GO:0051427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92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0.5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15.4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70067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otein Serine/Threonine Kinase Activity (GO:0004674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1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.4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3.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98533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alcium Ion Binding (GO:0005509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1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.2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2.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89805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otein Serine/Threonine/Tyrosine Kinase Activity (GO:0004712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1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8.7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85.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76671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otein Tyrosine Kinase Activator Activity (GO:0030296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2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9.2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35.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36597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n-Membrane Spanning Protein Tyrosine Kinase Activity (GO:0004715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5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3.3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66223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ransmembrane Receptor Protein Kinase Activity (GO:0019199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5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61.5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46.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5297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96299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E8EE7671-9609-4904-8B9F-73B692028CEA}"/>
              </a:ext>
            </a:extLst>
          </p:cNvPr>
          <p:cNvSpPr/>
          <p:nvPr/>
        </p:nvSpPr>
        <p:spPr>
          <a:xfrm>
            <a:off x="2169850" y="1054471"/>
            <a:ext cx="84359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inicopathologically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ificant mutant genes found in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0 patients in the Korean-KIRP database. 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2110128" y="5190188"/>
            <a:ext cx="839412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ly significant values are bolded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is used for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&lt;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. The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are from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isher’s exact test. CI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idence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val; </a:t>
            </a:r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N</a:t>
            </a:r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paroscopic Radical Nephrectomy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3115069"/>
              </p:ext>
            </p:extLst>
          </p:nvPr>
        </p:nvGraphicFramePr>
        <p:xfrm>
          <a:off x="2169851" y="1392199"/>
          <a:ext cx="8334402" cy="3737260"/>
        </p:xfrm>
        <a:graphic>
          <a:graphicData uri="http://schemas.openxmlformats.org/drawingml/2006/table">
            <a:tbl>
              <a:tblPr/>
              <a:tblGrid>
                <a:gridCol w="1571453">
                  <a:extLst>
                    <a:ext uri="{9D8B030D-6E8A-4147-A177-3AD203B41FA5}">
                      <a16:colId xmlns:a16="http://schemas.microsoft.com/office/drawing/2014/main" val="14251155"/>
                    </a:ext>
                  </a:extLst>
                </a:gridCol>
                <a:gridCol w="1200933">
                  <a:extLst>
                    <a:ext uri="{9D8B030D-6E8A-4147-A177-3AD203B41FA5}">
                      <a16:colId xmlns:a16="http://schemas.microsoft.com/office/drawing/2014/main" val="1827179127"/>
                    </a:ext>
                  </a:extLst>
                </a:gridCol>
                <a:gridCol w="1313708">
                  <a:extLst>
                    <a:ext uri="{9D8B030D-6E8A-4147-A177-3AD203B41FA5}">
                      <a16:colId xmlns:a16="http://schemas.microsoft.com/office/drawing/2014/main" val="2288244515"/>
                    </a:ext>
                  </a:extLst>
                </a:gridCol>
                <a:gridCol w="1268202">
                  <a:extLst>
                    <a:ext uri="{9D8B030D-6E8A-4147-A177-3AD203B41FA5}">
                      <a16:colId xmlns:a16="http://schemas.microsoft.com/office/drawing/2014/main" val="2878533347"/>
                    </a:ext>
                  </a:extLst>
                </a:gridCol>
                <a:gridCol w="1550747">
                  <a:extLst>
                    <a:ext uri="{9D8B030D-6E8A-4147-A177-3AD203B41FA5}">
                      <a16:colId xmlns:a16="http://schemas.microsoft.com/office/drawing/2014/main" val="3210096139"/>
                    </a:ext>
                  </a:extLst>
                </a:gridCol>
                <a:gridCol w="1429359">
                  <a:extLst>
                    <a:ext uri="{9D8B030D-6E8A-4147-A177-3AD203B41FA5}">
                      <a16:colId xmlns:a16="http://schemas.microsoft.com/office/drawing/2014/main" val="1060371453"/>
                    </a:ext>
                  </a:extLst>
                </a:gridCol>
              </a:tblGrid>
              <a:tr h="3254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linicopathologic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actors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ample with </a:t>
                      </a:r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utation, N=60 (%)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dds ratio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5% C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valu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7434504"/>
                  </a:ext>
                </a:extLst>
              </a:tr>
              <a:tr h="1710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g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KIF26A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3 (21.7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.24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32-470.39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1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9653185"/>
                  </a:ext>
                </a:extLst>
              </a:tr>
              <a:tr h="17106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ex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ISD3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13 (21.7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8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-0.82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2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992370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IMS2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1 (51.7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.03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00-20.12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7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8715846"/>
                  </a:ext>
                </a:extLst>
              </a:tr>
              <a:tr h="171060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umor siz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L6ST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 (33.3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3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-0.82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3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9151949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YH10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7 (11.7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5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-1.28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3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5939033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PATA13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9 (1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1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-0.80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3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4800879"/>
                  </a:ext>
                </a:extLst>
              </a:tr>
              <a:tr h="171060"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umor typ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UBP1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 (20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5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-0.70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6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7558349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ABRQ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6 (43.3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9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-0.77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4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5436977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ED12L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1 (3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5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6-1.00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9* 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4852621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DH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 (6.7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0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2-1.31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5* 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4974109"/>
                  </a:ext>
                </a:extLst>
              </a:tr>
              <a:tr h="171060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T stag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L6ST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20 (33.3)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22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5-0.9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2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4252900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ATA13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 (15.0)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16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-0.8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8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908074"/>
                  </a:ext>
                </a:extLst>
              </a:tr>
              <a:tr h="1710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 stag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L6ST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20 (33.3)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nfinite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87-Infinit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3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7961741"/>
                  </a:ext>
                </a:extLst>
              </a:tr>
              <a:tr h="1710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 stag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FDP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 (1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83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1.25-66.35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3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7396618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K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3 (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.50 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71-</a:t>
                      </a:r>
                      <a:r>
                        <a:rPr lang="en-US" altLang="ko-KR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012.77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4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8522773"/>
                  </a:ext>
                </a:extLst>
              </a:tr>
              <a:tr h="1710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currence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FDP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 (1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8.83 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1.25-66.35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3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6153023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K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3 (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5.50 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71-1012.77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4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2856643"/>
                  </a:ext>
                </a:extLst>
              </a:tr>
              <a:tr h="136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eath</a:t>
                      </a: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ISD3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13 (21.7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2.96 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93-735.68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9* 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3638288"/>
                  </a:ext>
                </a:extLst>
              </a:tr>
              <a:tr h="17106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sponse to </a:t>
                      </a:r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R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FDP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 (1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1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02-0.80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13*</a:t>
                      </a:r>
                      <a:endParaRPr lang="en-US" altLang="ko-KR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0975216"/>
                  </a:ext>
                </a:extLst>
              </a:tr>
              <a:tr h="17106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K1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3 (5.0)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6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001-1.40</a:t>
                      </a:r>
                      <a:endParaRPr lang="en-US" altLang="ko-KR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44*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298" marR="9298" marT="92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39942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43852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표 7"/>
          <p:cNvGraphicFramePr>
            <a:graphicFrameLocks noGrp="1"/>
          </p:cNvGraphicFramePr>
          <p:nvPr>
            <p:extLst/>
          </p:nvPr>
        </p:nvGraphicFramePr>
        <p:xfrm>
          <a:off x="2463115" y="2089728"/>
          <a:ext cx="6390768" cy="1951650"/>
        </p:xfrm>
        <a:graphic>
          <a:graphicData uri="http://schemas.openxmlformats.org/drawingml/2006/table">
            <a:tbl>
              <a:tblPr/>
              <a:tblGrid>
                <a:gridCol w="1288800">
                  <a:extLst>
                    <a:ext uri="{9D8B030D-6E8A-4147-A177-3AD203B41FA5}">
                      <a16:colId xmlns:a16="http://schemas.microsoft.com/office/drawing/2014/main" val="1641649343"/>
                    </a:ext>
                  </a:extLst>
                </a:gridCol>
                <a:gridCol w="1275492">
                  <a:extLst>
                    <a:ext uri="{9D8B030D-6E8A-4147-A177-3AD203B41FA5}">
                      <a16:colId xmlns:a16="http://schemas.microsoft.com/office/drawing/2014/main" val="256464592"/>
                    </a:ext>
                  </a:extLst>
                </a:gridCol>
                <a:gridCol w="1275492">
                  <a:extLst>
                    <a:ext uri="{9D8B030D-6E8A-4147-A177-3AD203B41FA5}">
                      <a16:colId xmlns:a16="http://schemas.microsoft.com/office/drawing/2014/main" val="4292823622"/>
                    </a:ext>
                  </a:extLst>
                </a:gridCol>
                <a:gridCol w="1275492">
                  <a:extLst>
                    <a:ext uri="{9D8B030D-6E8A-4147-A177-3AD203B41FA5}">
                      <a16:colId xmlns:a16="http://schemas.microsoft.com/office/drawing/2014/main" val="44450689"/>
                    </a:ext>
                  </a:extLst>
                </a:gridCol>
                <a:gridCol w="1275492">
                  <a:extLst>
                    <a:ext uri="{9D8B030D-6E8A-4147-A177-3AD203B41FA5}">
                      <a16:colId xmlns:a16="http://schemas.microsoft.com/office/drawing/2014/main" val="3594032246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linical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ariabl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tatisti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JAK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CSK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PATA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8131709"/>
                  </a:ext>
                </a:extLst>
              </a:tr>
              <a:tr h="1764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T stag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R (CI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7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, 21.05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(0.05, 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 </a:t>
                      </a:r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0.00, 10.41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0106501"/>
                  </a:ext>
                </a:extLst>
              </a:tr>
              <a:tr h="1764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value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3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1886874"/>
                  </a:ext>
                </a:extLst>
              </a:tr>
              <a:tr h="1764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 stag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R (CI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.51 (0.07, 440.90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.51 </a:t>
                      </a:r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</a:t>
                      </a:r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7, 440.90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(0.14, 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0308159"/>
                  </a:ext>
                </a:extLst>
              </a:tr>
              <a:tr h="1764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value</a:t>
                      </a:r>
                      <a:endParaRPr lang="en-US" sz="10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8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5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0348655"/>
                  </a:ext>
                </a:extLst>
              </a:tr>
              <a:tr h="1764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 stag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R (CI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7.36 (0.21, 1407.16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 (0.00, 92.02)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6 (1.0, 1.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0161414"/>
                  </a:ext>
                </a:extLst>
              </a:tr>
              <a:tr h="1764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value</a:t>
                      </a:r>
                      <a:endParaRPr lang="en-US" sz="10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1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1.00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657724"/>
                  </a:ext>
                </a:extLst>
              </a:tr>
              <a:tr h="1764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ecurrenc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R (CI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(1.0, 1.0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4.81 (0.99, 1.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(0.11, 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nf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936029"/>
                  </a:ext>
                </a:extLst>
              </a:tr>
              <a:tr h="1764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value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30*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3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7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7436573"/>
                  </a:ext>
                </a:extLst>
              </a:tr>
              <a:tr h="1764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eat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OR (CI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5.94 (0.07, 470.94)</a:t>
                      </a:r>
                      <a:endParaRPr kumimoji="0" lang="en-US" altLang="ko-KR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1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Inf</a:t>
                      </a: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 (1.12, </a:t>
                      </a:r>
                      <a:r>
                        <a:rPr kumimoji="0" lang="en-US" altLang="ko-KR" sz="11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Inf</a:t>
                      </a: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)</a:t>
                      </a:r>
                      <a:endParaRPr kumimoji="0" lang="en-US" altLang="ko-KR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1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Inf</a:t>
                      </a: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 (0.15, </a:t>
                      </a:r>
                      <a:r>
                        <a:rPr kumimoji="0" lang="en-US" altLang="ko-KR" sz="1100" b="0" i="0" u="none" strike="noStrike" kern="1200" cap="none" spc="0" normalizeH="0" baseline="0" noProof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Inf</a:t>
                      </a: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)</a:t>
                      </a:r>
                      <a:endParaRPr kumimoji="0" lang="en-US" altLang="ko-KR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169829"/>
                  </a:ext>
                </a:extLst>
              </a:tr>
              <a:tr h="176400">
                <a:tc v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value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0.270</a:t>
                      </a:r>
                      <a:endParaRPr kumimoji="0" lang="en-US" altLang="ko-KR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+mn-cs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1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0.021*</a:t>
                      </a:r>
                      <a:endParaRPr kumimoji="0" lang="en-US" altLang="ko-KR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11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+mn-cs"/>
                        </a:rPr>
                        <a:t>0.145</a:t>
                      </a:r>
                      <a:endParaRPr kumimoji="0" lang="en-US" altLang="ko-KR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0598282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389968" y="1575295"/>
            <a:ext cx="63907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Table S4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s of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inicopathologic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tors with the three survival-specific genes (</a:t>
            </a:r>
            <a:r>
              <a:rPr lang="en-US" altLang="ko-KR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K1, PCSK2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ko-KR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ATA13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in the TCGA-KIRP database.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2389968" y="4146913"/>
            <a:ext cx="677145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ly significant values are bolded. * is used for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&lt; 0.05. The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are from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isher’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ct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. CI, Confidence interval; OR, Odds ratio; </a:t>
            </a:r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N, </a:t>
            </a:r>
            <a:r>
              <a:rPr lang="en-US" altLang="ko-KR" sz="1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paroscopic Radical </a:t>
            </a:r>
            <a:r>
              <a:rPr lang="en-US" altLang="ko-KR" sz="1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phrectomy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20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6</TotalTime>
  <Words>863</Words>
  <Application>Microsoft Office PowerPoint</Application>
  <PresentationFormat>와이드스크린</PresentationFormat>
  <Paragraphs>330</Paragraphs>
  <Slides>4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Times New Roman</vt:lpstr>
      <vt:lpstr>Wingdings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</cp:revision>
  <dcterms:created xsi:type="dcterms:W3CDTF">2024-04-15T23:05:30Z</dcterms:created>
  <dcterms:modified xsi:type="dcterms:W3CDTF">2024-04-18T01:22:06Z</dcterms:modified>
</cp:coreProperties>
</file>